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253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013"/>
            </a:lvl1pPr>
            <a:lvl2pPr marL="192881" indent="0" algn="ctr">
              <a:buNone/>
              <a:defRPr sz="844"/>
            </a:lvl2pPr>
            <a:lvl3pPr marL="385763" indent="0" algn="ctr">
              <a:buNone/>
              <a:defRPr sz="759"/>
            </a:lvl3pPr>
            <a:lvl4pPr marL="578644" indent="0" algn="ctr">
              <a:buNone/>
              <a:defRPr sz="675"/>
            </a:lvl4pPr>
            <a:lvl5pPr marL="771525" indent="0" algn="ctr">
              <a:buNone/>
              <a:defRPr sz="675"/>
            </a:lvl5pPr>
            <a:lvl6pPr marL="964406" indent="0" algn="ctr">
              <a:buNone/>
              <a:defRPr sz="675"/>
            </a:lvl6pPr>
            <a:lvl7pPr marL="1157288" indent="0" algn="ctr">
              <a:buNone/>
              <a:defRPr sz="675"/>
            </a:lvl7pPr>
            <a:lvl8pPr marL="1350169" indent="0" algn="ctr">
              <a:buNone/>
              <a:defRPr sz="675"/>
            </a:lvl8pPr>
            <a:lvl9pPr marL="1543050" indent="0" algn="ctr">
              <a:buNone/>
              <a:defRPr sz="67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49106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1639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4225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424821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9"/>
            <a:ext cx="10515600" cy="2852737"/>
          </a:xfrm>
        </p:spPr>
        <p:txBody>
          <a:bodyPr anchor="b"/>
          <a:lstStyle>
            <a:lvl1pPr>
              <a:defRPr sz="253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013">
                <a:solidFill>
                  <a:schemeClr val="tx1"/>
                </a:solidFill>
              </a:defRPr>
            </a:lvl1pPr>
            <a:lvl2pPr marL="192881" indent="0">
              <a:buNone/>
              <a:defRPr sz="844">
                <a:solidFill>
                  <a:schemeClr val="tx1">
                    <a:tint val="75000"/>
                  </a:schemeClr>
                </a:solidFill>
              </a:defRPr>
            </a:lvl2pPr>
            <a:lvl3pPr marL="385763" indent="0">
              <a:buNone/>
              <a:defRPr sz="759">
                <a:solidFill>
                  <a:schemeClr val="tx1">
                    <a:tint val="75000"/>
                  </a:schemeClr>
                </a:solidFill>
              </a:defRPr>
            </a:lvl3pPr>
            <a:lvl4pPr marL="578644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4pPr>
            <a:lvl5pPr marL="771525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5pPr>
            <a:lvl6pPr marL="964406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6pPr>
            <a:lvl7pPr marL="1157288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7pPr>
            <a:lvl8pPr marL="1350169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8pPr>
            <a:lvl9pPr marL="1543050" indent="0">
              <a:buNone/>
              <a:defRPr sz="6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343214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0193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013" b="1"/>
            </a:lvl1pPr>
            <a:lvl2pPr marL="192881" indent="0">
              <a:buNone/>
              <a:defRPr sz="844" b="1"/>
            </a:lvl2pPr>
            <a:lvl3pPr marL="385763" indent="0">
              <a:buNone/>
              <a:defRPr sz="759" b="1"/>
            </a:lvl3pPr>
            <a:lvl4pPr marL="578644" indent="0">
              <a:buNone/>
              <a:defRPr sz="675" b="1"/>
            </a:lvl4pPr>
            <a:lvl5pPr marL="771525" indent="0">
              <a:buNone/>
              <a:defRPr sz="675" b="1"/>
            </a:lvl5pPr>
            <a:lvl6pPr marL="964406" indent="0">
              <a:buNone/>
              <a:defRPr sz="675" b="1"/>
            </a:lvl6pPr>
            <a:lvl7pPr marL="1157288" indent="0">
              <a:buNone/>
              <a:defRPr sz="675" b="1"/>
            </a:lvl7pPr>
            <a:lvl8pPr marL="1350169" indent="0">
              <a:buNone/>
              <a:defRPr sz="675" b="1"/>
            </a:lvl8pPr>
            <a:lvl9pPr marL="1543050" indent="0">
              <a:buNone/>
              <a:defRPr sz="6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1013" b="1"/>
            </a:lvl1pPr>
            <a:lvl2pPr marL="192881" indent="0">
              <a:buNone/>
              <a:defRPr sz="844" b="1"/>
            </a:lvl2pPr>
            <a:lvl3pPr marL="385763" indent="0">
              <a:buNone/>
              <a:defRPr sz="759" b="1"/>
            </a:lvl3pPr>
            <a:lvl4pPr marL="578644" indent="0">
              <a:buNone/>
              <a:defRPr sz="675" b="1"/>
            </a:lvl4pPr>
            <a:lvl5pPr marL="771525" indent="0">
              <a:buNone/>
              <a:defRPr sz="675" b="1"/>
            </a:lvl5pPr>
            <a:lvl6pPr marL="964406" indent="0">
              <a:buNone/>
              <a:defRPr sz="675" b="1"/>
            </a:lvl6pPr>
            <a:lvl7pPr marL="1157288" indent="0">
              <a:buNone/>
              <a:defRPr sz="675" b="1"/>
            </a:lvl7pPr>
            <a:lvl8pPr marL="1350169" indent="0">
              <a:buNone/>
              <a:defRPr sz="675" b="1"/>
            </a:lvl8pPr>
            <a:lvl9pPr marL="1543050" indent="0">
              <a:buNone/>
              <a:defRPr sz="67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24922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63360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0055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3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1350"/>
            </a:lvl1pPr>
            <a:lvl2pPr>
              <a:defRPr sz="1181"/>
            </a:lvl2pPr>
            <a:lvl3pPr>
              <a:defRPr sz="1013"/>
            </a:lvl3pPr>
            <a:lvl4pPr>
              <a:defRPr sz="844"/>
            </a:lvl4pPr>
            <a:lvl5pPr>
              <a:defRPr sz="844"/>
            </a:lvl5pPr>
            <a:lvl6pPr>
              <a:defRPr sz="844"/>
            </a:lvl6pPr>
            <a:lvl7pPr>
              <a:defRPr sz="844"/>
            </a:lvl7pPr>
            <a:lvl8pPr>
              <a:defRPr sz="844"/>
            </a:lvl8pPr>
            <a:lvl9pPr>
              <a:defRPr sz="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675"/>
            </a:lvl1pPr>
            <a:lvl2pPr marL="192881" indent="0">
              <a:buNone/>
              <a:defRPr sz="591"/>
            </a:lvl2pPr>
            <a:lvl3pPr marL="385763" indent="0">
              <a:buNone/>
              <a:defRPr sz="506"/>
            </a:lvl3pPr>
            <a:lvl4pPr marL="578644" indent="0">
              <a:buNone/>
              <a:defRPr sz="422"/>
            </a:lvl4pPr>
            <a:lvl5pPr marL="771525" indent="0">
              <a:buNone/>
              <a:defRPr sz="422"/>
            </a:lvl5pPr>
            <a:lvl6pPr marL="964406" indent="0">
              <a:buNone/>
              <a:defRPr sz="422"/>
            </a:lvl6pPr>
            <a:lvl7pPr marL="1157288" indent="0">
              <a:buNone/>
              <a:defRPr sz="422"/>
            </a:lvl7pPr>
            <a:lvl8pPr marL="1350169" indent="0">
              <a:buNone/>
              <a:defRPr sz="422"/>
            </a:lvl8pPr>
            <a:lvl9pPr marL="1543050" indent="0">
              <a:buNone/>
              <a:defRPr sz="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08977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13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1350"/>
            </a:lvl1pPr>
            <a:lvl2pPr marL="192881" indent="0">
              <a:buNone/>
              <a:defRPr sz="1181"/>
            </a:lvl2pPr>
            <a:lvl3pPr marL="385763" indent="0">
              <a:buNone/>
              <a:defRPr sz="1013"/>
            </a:lvl3pPr>
            <a:lvl4pPr marL="578644" indent="0">
              <a:buNone/>
              <a:defRPr sz="844"/>
            </a:lvl4pPr>
            <a:lvl5pPr marL="771525" indent="0">
              <a:buNone/>
              <a:defRPr sz="844"/>
            </a:lvl5pPr>
            <a:lvl6pPr marL="964406" indent="0">
              <a:buNone/>
              <a:defRPr sz="844"/>
            </a:lvl6pPr>
            <a:lvl7pPr marL="1157288" indent="0">
              <a:buNone/>
              <a:defRPr sz="844"/>
            </a:lvl7pPr>
            <a:lvl8pPr marL="1350169" indent="0">
              <a:buNone/>
              <a:defRPr sz="844"/>
            </a:lvl8pPr>
            <a:lvl9pPr marL="1543050" indent="0">
              <a:buNone/>
              <a:defRPr sz="84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675"/>
            </a:lvl1pPr>
            <a:lvl2pPr marL="192881" indent="0">
              <a:buNone/>
              <a:defRPr sz="591"/>
            </a:lvl2pPr>
            <a:lvl3pPr marL="385763" indent="0">
              <a:buNone/>
              <a:defRPr sz="506"/>
            </a:lvl3pPr>
            <a:lvl4pPr marL="578644" indent="0">
              <a:buNone/>
              <a:defRPr sz="422"/>
            </a:lvl4pPr>
            <a:lvl5pPr marL="771525" indent="0">
              <a:buNone/>
              <a:defRPr sz="422"/>
            </a:lvl5pPr>
            <a:lvl6pPr marL="964406" indent="0">
              <a:buNone/>
              <a:defRPr sz="422"/>
            </a:lvl6pPr>
            <a:lvl7pPr marL="1157288" indent="0">
              <a:buNone/>
              <a:defRPr sz="422"/>
            </a:lvl7pPr>
            <a:lvl8pPr marL="1350169" indent="0">
              <a:buNone/>
              <a:defRPr sz="422"/>
            </a:lvl8pPr>
            <a:lvl9pPr marL="1543050" indent="0">
              <a:buNone/>
              <a:defRPr sz="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34113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/>
            <a:fld id="{7D948975-9D4D-44E5-97B7-9FA80B3EBD7C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257175"/>
              <a:t>9/12/2022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0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257175"/>
            <a:fld id="{7C302557-C982-4693-857F-216372DD6836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257175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9086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85763" rtl="0" eaLnBrk="1" latinLnBrk="0" hangingPunct="1">
        <a:lnSpc>
          <a:spcPct val="90000"/>
        </a:lnSpc>
        <a:spcBef>
          <a:spcPct val="0"/>
        </a:spcBef>
        <a:buNone/>
        <a:defRPr sz="18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6441" indent="-96441" algn="l" defTabSz="385763" rtl="0" eaLnBrk="1" latinLnBrk="0" hangingPunct="1">
        <a:lnSpc>
          <a:spcPct val="90000"/>
        </a:lnSpc>
        <a:spcBef>
          <a:spcPts val="422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1pPr>
      <a:lvl2pPr marL="289322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482203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844" kern="1200">
          <a:solidFill>
            <a:schemeClr val="tx1"/>
          </a:solidFill>
          <a:latin typeface="+mn-lt"/>
          <a:ea typeface="+mn-ea"/>
          <a:cs typeface="+mn-cs"/>
        </a:defRPr>
      </a:lvl3pPr>
      <a:lvl4pPr marL="675084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4pPr>
      <a:lvl5pPr marL="867966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5pPr>
      <a:lvl6pPr marL="1060847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6pPr>
      <a:lvl7pPr marL="1253728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7pPr>
      <a:lvl8pPr marL="1446609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8pPr>
      <a:lvl9pPr marL="1639491" indent="-96441" algn="l" defTabSz="385763" rtl="0" eaLnBrk="1" latinLnBrk="0" hangingPunct="1">
        <a:lnSpc>
          <a:spcPct val="90000"/>
        </a:lnSpc>
        <a:spcBef>
          <a:spcPts val="211"/>
        </a:spcBef>
        <a:buFont typeface="Arial" panose="020B0604020202020204" pitchFamily="34" charset="0"/>
        <a:buChar char="•"/>
        <a:defRPr sz="7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1pPr>
      <a:lvl2pPr marL="192881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2pPr>
      <a:lvl3pPr marL="385763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3pPr>
      <a:lvl4pPr marL="578644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4pPr>
      <a:lvl5pPr marL="771525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5pPr>
      <a:lvl6pPr marL="964406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6pPr>
      <a:lvl7pPr marL="1157288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7pPr>
      <a:lvl8pPr marL="1350169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8pPr>
      <a:lvl9pPr marL="1543050" algn="l" defTabSz="385763" rtl="0" eaLnBrk="1" latinLnBrk="0" hangingPunct="1">
        <a:defRPr sz="7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xmlns="" id="{85E7870E-092F-4388-9BA7-1928874A36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0371" y="3242525"/>
            <a:ext cx="390838" cy="157900"/>
          </a:xfrm>
          <a:prstGeom prst="rect">
            <a:avLst/>
          </a:prstGeom>
          <a:solidFill>
            <a:srgbClr val="FFFF00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8932" tIns="14466" rIns="28932" bIns="14466" numCol="1" anchor="t" anchorCtr="0" compatLnSpc="1">
            <a:prstTxWarp prst="textNoShape">
              <a:avLst/>
            </a:prstTxWarp>
          </a:bodyPr>
          <a:lstStyle/>
          <a:p>
            <a:pPr algn="ctr" defTabSz="28932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88" b="1">
                <a:solidFill>
                  <a:prstClr val="black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 C3</a:t>
            </a:r>
            <a:endParaRPr lang="en-US" altLang="en-US" sz="788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xmlns="" id="{DC67171B-AE91-4B2C-AE30-9CFFAAC646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13495" y="3215301"/>
            <a:ext cx="58494" cy="1169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28932" tIns="14466" rIns="28932" bIns="14466" numCol="1" anchor="ctr" anchorCtr="0" compatLnSpc="1">
            <a:prstTxWarp prst="textNoShape">
              <a:avLst/>
            </a:prstTxWarp>
            <a:spAutoFit/>
          </a:bodyPr>
          <a:lstStyle/>
          <a:p>
            <a:pPr defTabSz="257175"/>
            <a:endParaRPr lang="en-GB" sz="570">
              <a:solidFill>
                <a:prstClr val="black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1AC40071-CB92-4D99-8720-2E84466811BF}"/>
              </a:ext>
            </a:extLst>
          </p:cNvPr>
          <p:cNvSpPr txBox="1"/>
          <p:nvPr/>
        </p:nvSpPr>
        <p:spPr>
          <a:xfrm>
            <a:off x="4371474" y="850232"/>
            <a:ext cx="2964437" cy="52503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AAGAAGGC GAAGTCATGA GCGCCGGGAT TTACCCCCTA ACCTTTATAT AAGAAACAA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ATATTACT GCTACAGGGA CCCAAGGACG GGTAAAGAGT TTGGATTAGG CAGAGACAG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GATTCGCAA TCACTGAAGC TATACAGGCC AACATTGAGT TATTTTCAGG ACACAAACA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GCCTCTGA CAGCGAGAAT CAACAGTGAT AATTCCGTTA CGTTACATTC ATGGCTTGA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GCTACGAAA AAATCCTGGC CAGCAGAGGA ATCAAGCAGA AGACACTCAT AAATTACAT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GCAAAATTA AAGCAATAAG GAGGGGTCTG CCTGATGCTC CACTTGAAGA CATCACCAC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AGAAATTG CGGCAATGCT CAATGGATAC ATAGACGAGG GCAAGGCGGC GTCAGCCAA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AATCAGAT CAACGCTGAG CGATGCATTC CGAGAGGCAA TAGCTGAAGG CCATATAAC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AAACCATG TCGCTGCCAC TCGCGCGGCA AAGTCAAAGG TAAGGAGATC AAGACTTAC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CTGACGAAT ACCTGAAAAT TTATCAAGCA GCAGAATCAT CACCATGTTG GCTCAGACT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CAATGGAAC TGGCTGTTGT TACCGGGCAA CGAGTTGGTG ACTTGTGCAA AATGAAGTG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TGATATCG TAGATGGATA TCTTTATGTC GAGCAAAGCA AAACAGGCGT AAAAATTGC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CCCAACAG CATTGCATAT TGATGCTCTC GGAATATCAA TGAAGGAAAC ACTTGATAA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CAAAGAGA TTCTTGGCGG AGAAACCATA ATTGCATCTA CTCGTCGCGA ACCGCTCTC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CGGCACAG TATCAAGGTA TTTTATGCGC GCACGAAAAG CATCAGGTCT TTCCTTCGA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GGATCCGC CTACCTTTCA CGAGTTGCGC AGTTTGTCTG CAAGACTCTA TGGGAAGCA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AAGCGATA AGTTTGCTCA ACATCTTCTC GGGCATAAGT CGGTCACCAT GGCATCACA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highlight>
                  <a:srgbClr val="FF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TCGTGATG ACAGAGGCAG GGAGTGGGAC AAAATTGAAA TCAAA</a:t>
            </a: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AAA AACGA</a:t>
            </a: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GGC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GCACCAAG TCAGAATTGA TAGAAAGACT TGCCACCCAG CAATCGCACA TTCCCGCCAA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CGGTTGAA GATGCAGTAA AAGAGATGCT GGAGCATATG GCCTCGACTC TTGCGCAGGG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GGAAGCGGC GGTCTTACAA AAGCTGAAAT GTCAGAATAT CTGTTTGATA AGCTTGGGCT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GCAAGCGG GATGCCAAAG AACTGGTTGA ACTGTTTTTC GAAGAGATCC GTCGCGCTCT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AAAACGGC GAACAGGTGA AACTCTCTGG TTTTGGTAAC TTCGATCTGC GTGATAAGAA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AACGCCCG GGACGTAACC CGAAAACGGG CGAGGATATT CCCATTACAG CACGGCGCGT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TGACCTTC AGACCCGGGC AGAAGTTAAA AAGCCGGGTC GAAAACGCTG GTGGGGGCGA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CGTATTGAA ATCCGCGGTT TCGGCAGTTT CTCTTTGCAC TACCGCGCAC CACGTACCGG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GTAATCCG AAGACTGGCG ATAAAGTAGA ACTGGAAGGA AAATACGTTC CTCACTTTAA </a:t>
            </a:r>
            <a:endParaRPr lang="en-US" sz="450" dirty="0">
              <a:solidFill>
                <a:prstClr val="black"/>
              </a:solidFill>
              <a:highlight>
                <a:srgbClr val="00FF00"/>
              </a:highlight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CTGGTAAA GAACTGCGCG ATCGCGCCAA TATCTACGGT GGATCAGGCT</a:t>
            </a:r>
            <a:r>
              <a:rPr lang="en-SG" sz="45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AAATAA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CGAAAGGCT CAGTCGAAAG ACTGGGCCTT TCGTTTTATC CTATTCC</a:t>
            </a:r>
            <a:r>
              <a:rPr lang="en-SG" sz="450" dirty="0">
                <a:solidFill>
                  <a:srgbClr val="0000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 GTTCCTATTC</a:t>
            </a: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CTAGAAAGT ATAGGAACTT CGGCGCGCCT ACCTGTGACG GAAGATCACT TCGCAGAAT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TAAATCCT GGTGTCCCTG TTGATACCGG GAAGCCCTGG GCCAACTTTT GGCGAAAATG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GACGTTGAT CGGCACGTAA GAGGTTCCAA CTTTCACCAT AATGAAATAA GATCACTAC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GCGTATTT TTTGAGTTGT CGAGATTTTC AGGAGCTAAG </a:t>
            </a: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GCTAAAA TGGAGAAAA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ATCACTGGA TATACCACCG TTGATATATC CCAATGGCAT CGTAAAGAAC ATTTTGAGG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TTCAGTCA GTTGCTCAAT GTACCTATAA CCAGACCGTT CAGCTGGATA TTACGGCCT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AAAGACC GTAAAGAAAA ATAAGCACAA GTTTTATCCG GCCTTTATTC ACATTCTTG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CGCCTGATG AATGCTCATC CGGAATTACG TATGGCAATG AAAGACGGTG AGCTGGTGA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GGGATAGT GTTCACCCTT GTTACACCGT TTTCCATGAG CAAACTGAAA CGTTTTCATC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CTCTGGAGT GAATACCACG ACGATTTCCG GCAGTTTCTA CACATATATT CGCAAGATG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CGTGTTAC GGTGAAAACC TGGCCTATTT CCCTAAAGGG TTTATTGAGA ATATGTTTT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GTCTCAGCC AATCCCTGGG TGAGTTTCAC CAGTTTTGAT TTAAACGTGG CCAATATGG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ACTTCTTC GCCCCCGTTT TCACCATGGG CAAATATTAT ACGCAAGGCG ACAAGGTGC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TGCCGCTG GCGATTCAGG TTCATCATGC CGTTTGTGAT GGCTTCCATG TCGGCAGAA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srgbClr val="000000"/>
                </a:solidFill>
                <a:highlight>
                  <a:srgbClr val="FF0000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CTTAATGAA TTACAACAGT ACTGCGATGA GTGGCAGGGC</a:t>
            </a:r>
            <a:r>
              <a:rPr lang="en-SG" sz="45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</a:t>
            </a: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GGGCGTAAG GCGCGCCATT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AAT</a:t>
            </a:r>
            <a:r>
              <a:rPr lang="en-SG" sz="450" dirty="0">
                <a:solidFill>
                  <a:srgbClr val="000000"/>
                </a:solidFill>
                <a:highlight>
                  <a:srgbClr val="0000FF"/>
                </a:highlight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AAGT TCCTATTC</a:t>
            </a: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G AAGTTCCTAT TCTCTAGAAA GTATAGGAAC TTCGACTGTA 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algn="just" defTabSz="257175">
              <a:lnSpc>
                <a:spcPct val="107000"/>
              </a:lnSpc>
              <a:spcAft>
                <a:spcPts val="253"/>
              </a:spcAft>
              <a:tabLst>
                <a:tab pos="184041" algn="l"/>
                <a:tab pos="368082" algn="l"/>
                <a:tab pos="552122" algn="l"/>
                <a:tab pos="736163" algn="l"/>
                <a:tab pos="920204" algn="l"/>
                <a:tab pos="1104245" algn="l"/>
                <a:tab pos="1288286" algn="l"/>
                <a:tab pos="1472327" algn="l"/>
                <a:tab pos="1656368" algn="l"/>
                <a:tab pos="1840409" algn="l"/>
                <a:tab pos="2024449" algn="l"/>
                <a:tab pos="2208490" algn="l"/>
                <a:tab pos="2392531" algn="l"/>
                <a:tab pos="2576572" algn="l"/>
                <a:tab pos="2760613" algn="l"/>
                <a:tab pos="2944654" algn="l"/>
              </a:tabLst>
            </a:pPr>
            <a:r>
              <a:rPr lang="en-SG" sz="45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AAAACCACA GCC</a:t>
            </a:r>
            <a:endParaRPr lang="en-US" sz="450" dirty="0">
              <a:solidFill>
                <a:prstClr val="black"/>
              </a:solidFill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</p:txBody>
      </p:sp>
      <p:sp>
        <p:nvSpPr>
          <p:cNvPr id="12" name="Text Box 1">
            <a:extLst>
              <a:ext uri="{FF2B5EF4-FFF2-40B4-BE49-F238E27FC236}">
                <a16:creationId xmlns:a16="http://schemas.microsoft.com/office/drawing/2014/main" xmlns="" id="{1210C566-145C-48B9-9810-79774D83A5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3943" y="3453265"/>
            <a:ext cx="390838" cy="157900"/>
          </a:xfrm>
          <a:prstGeom prst="rect">
            <a:avLst/>
          </a:prstGeom>
          <a:solidFill>
            <a:srgbClr val="99FF33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8932" tIns="14466" rIns="28932" bIns="14466" numCol="1" anchor="t" anchorCtr="0" compatLnSpc="1">
            <a:prstTxWarp prst="textNoShape">
              <a:avLst/>
            </a:prstTxWarp>
          </a:bodyPr>
          <a:lstStyle/>
          <a:p>
            <a:pPr algn="ctr" defTabSz="28932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88" b="1" dirty="0">
                <a:solidFill>
                  <a:prstClr val="black"/>
                </a:solidFill>
                <a:highlight>
                  <a:srgbClr val="00FF00"/>
                </a:highlight>
                <a:latin typeface="Times New Roman" panose="02020603050405020304" pitchFamily="18" charset="0"/>
                <a:cs typeface="Times New Roman" panose="02020603050405020304" pitchFamily="18" charset="0"/>
              </a:rPr>
              <a:t>scIHF2</a:t>
            </a:r>
            <a:endParaRPr lang="en-US" altLang="en-US" sz="788" dirty="0">
              <a:solidFill>
                <a:prstClr val="black"/>
              </a:solidFill>
              <a:highlight>
                <a:srgbClr val="00FF00"/>
              </a:highlight>
              <a:latin typeface="Arial" panose="020B0604020202020204" pitchFamily="34" charset="0"/>
            </a:endParaRPr>
          </a:p>
        </p:txBody>
      </p:sp>
      <p:sp>
        <p:nvSpPr>
          <p:cNvPr id="13" name="Text Box 1">
            <a:extLst>
              <a:ext uri="{FF2B5EF4-FFF2-40B4-BE49-F238E27FC236}">
                <a16:creationId xmlns:a16="http://schemas.microsoft.com/office/drawing/2014/main" xmlns="" id="{52ADD462-0D5E-462E-AB06-7620E53A35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89301" y="3672936"/>
            <a:ext cx="390838" cy="157900"/>
          </a:xfrm>
          <a:prstGeom prst="rect">
            <a:avLst/>
          </a:prstGeom>
          <a:solidFill>
            <a:srgbClr val="3399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8932" tIns="14466" rIns="28932" bIns="14466" numCol="1" anchor="t" anchorCtr="0" compatLnSpc="1">
            <a:prstTxWarp prst="textNoShape">
              <a:avLst/>
            </a:prstTxWarp>
          </a:bodyPr>
          <a:lstStyle/>
          <a:p>
            <a:pPr algn="ctr" defTabSz="28932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88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T</a:t>
            </a:r>
            <a:endParaRPr lang="en-US" altLang="en-US" sz="788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  <p:sp>
        <p:nvSpPr>
          <p:cNvPr id="14" name="Text Box 1">
            <a:extLst>
              <a:ext uri="{FF2B5EF4-FFF2-40B4-BE49-F238E27FC236}">
                <a16:creationId xmlns:a16="http://schemas.microsoft.com/office/drawing/2014/main" xmlns="" id="{8CD208C6-190B-4FF2-AC17-85E31D8B7F3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394659" y="3876533"/>
            <a:ext cx="390838" cy="157900"/>
          </a:xfrm>
          <a:prstGeom prst="rect">
            <a:avLst/>
          </a:prstGeom>
          <a:solidFill>
            <a:srgbClr val="FF0066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28932" tIns="14466" rIns="28932" bIns="14466" numCol="1" anchor="t" anchorCtr="0" compatLnSpc="1">
            <a:prstTxWarp prst="textNoShape">
              <a:avLst/>
            </a:prstTxWarp>
          </a:bodyPr>
          <a:lstStyle/>
          <a:p>
            <a:pPr algn="ctr" defTabSz="289322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788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T</a:t>
            </a:r>
            <a:endParaRPr lang="en-US" altLang="en-US" sz="788" dirty="0">
              <a:solidFill>
                <a:prstClr val="black"/>
              </a:solidFill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340713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7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Droge (Assoc Prof)</dc:creator>
  <cp:lastModifiedBy>Peter Droge (Assoc Prof)</cp:lastModifiedBy>
  <cp:revision>1</cp:revision>
  <dcterms:created xsi:type="dcterms:W3CDTF">2022-09-12T01:59:16Z</dcterms:created>
  <dcterms:modified xsi:type="dcterms:W3CDTF">2022-09-12T02:00:20Z</dcterms:modified>
</cp:coreProperties>
</file>